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95"/>
    <p:restoredTop sz="75000"/>
  </p:normalViewPr>
  <p:slideViewPr>
    <p:cSldViewPr snapToGrid="0">
      <p:cViewPr>
        <p:scale>
          <a:sx n="97" d="100"/>
          <a:sy n="97" d="100"/>
        </p:scale>
        <p:origin x="2040" y="-2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6A67D7-43CE-BA47-9C16-BA5904AA77B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30AD52-1D72-6943-8244-BC923B219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80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30AD52-1D72-6943-8244-BC923B219EA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985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038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12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21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03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6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818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104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1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330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9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435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80E22-9499-0F4C-8EC4-A3C0CC1B4368}" type="datetimeFigureOut">
              <a:rPr lang="en-US" smtClean="0"/>
              <a:t>11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7A1B7-D997-E840-B093-08B6ACB5A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727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200A4EA-D90E-CEA4-49BD-320D533706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1100" y="704850"/>
            <a:ext cx="4495800" cy="3505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8DF31DF-B9D9-ED82-682F-EFE2860139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700" y="4819650"/>
            <a:ext cx="5537200" cy="2921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FD82BB5-B3E4-9ECF-CB08-E0C4CEFC30B0}"/>
              </a:ext>
            </a:extLst>
          </p:cNvPr>
          <p:cNvSpPr txBox="1"/>
          <p:nvPr/>
        </p:nvSpPr>
        <p:spPr>
          <a:xfrm>
            <a:off x="550050" y="46452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5098FF6-69A4-11B4-DFCA-466B8B907AA4}"/>
              </a:ext>
            </a:extLst>
          </p:cNvPr>
          <p:cNvSpPr txBox="1"/>
          <p:nvPr/>
        </p:nvSpPr>
        <p:spPr>
          <a:xfrm>
            <a:off x="546100" y="66675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EB6916-3582-376B-9B32-F6B9527C3364}"/>
              </a:ext>
            </a:extLst>
          </p:cNvPr>
          <p:cNvSpPr txBox="1"/>
          <p:nvPr/>
        </p:nvSpPr>
        <p:spPr>
          <a:xfrm>
            <a:off x="393700" y="8039100"/>
            <a:ext cx="59880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molecular structure of the antibody-drug conjugate mirvetuximab soravtansine (MIRV) and its cytotoxic payload. Panel A illustrates the monoclonal antibody component targeting folate receptor alpha (FOLR1) also referred to as M9346A, conjugated to four units of the tubulin inhibit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avtansi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DM4), 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ytansinoi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erivative, via lysine residues using the NHS ester group 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ulf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PDB. Panel B shows the chemical structure of the DM4 payload and the linker moiety. On average, each M9346A antibody is conjugated to approximately 3.4 DM4 payloa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molecul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342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7</TotalTime>
  <Words>104</Words>
  <Application>Microsoft Macintosh PowerPoint</Application>
  <PresentationFormat>A4 Paper (210x297 mm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dical writer</dc:creator>
  <cp:lastModifiedBy>Medical writer</cp:lastModifiedBy>
  <cp:revision>6</cp:revision>
  <dcterms:created xsi:type="dcterms:W3CDTF">2025-11-11T06:11:09Z</dcterms:created>
  <dcterms:modified xsi:type="dcterms:W3CDTF">2025-11-12T11:18:56Z</dcterms:modified>
</cp:coreProperties>
</file>